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5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7102475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2725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B81B86-67AD-4A80-82AB-63043A0106D7}" type="datetimeFigureOut">
              <a:rPr lang="en-GB" smtClean="0"/>
              <a:t>26/01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81013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2725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48A68E-FF18-4D39-B656-39F2923390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112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699923-F681-403F-B33E-D88125F3A0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6C63C2-2F58-4738-8EB3-D21E62EC92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A5226B-BB4F-40CC-A23D-C6042F579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DA341-4DD7-4F0D-88C0-7F5DEDC576AB}" type="datetime1">
              <a:rPr lang="en-GB" smtClean="0"/>
              <a:t>26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6D1561-DC32-4DFF-A557-25E1BE7B2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5FA51B-335C-4DDB-BD1C-050BC13EC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6655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3B5A4-B9D7-4A8E-81BA-9EA6B066D1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56D03A-11A3-4445-8FBF-394084BAC4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BB6DEF-4F9C-436C-BF36-D09627A28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CCBBE-0C47-4971-9983-5F4900F116CA}" type="datetime1">
              <a:rPr lang="en-GB" smtClean="0"/>
              <a:t>26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147744-5BAF-4180-A8BD-81AECCE88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B152A1-B4C7-46E2-B0D1-D81CEB3D8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178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05174F-7AEE-4EAF-BEF3-CA89B3A73F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C38EF2-5EFB-4A7F-985D-2DAF7DD66A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75DEE9-FCAF-419F-9766-2386C29F4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C04C9-11A2-40A0-AD04-C4066D502BAF}" type="datetime1">
              <a:rPr lang="en-GB" smtClean="0"/>
              <a:t>26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8D424-D0EF-458F-BF1B-DE7FABA40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897286-8467-41D7-91F5-BF7DED527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3526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0BE187-6F2F-4DF2-BB9D-2A70A8B27E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3E48E6-7801-41DD-888F-DA0331A1E6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0DED79-F8A0-408D-917A-E4E5F0964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AC4A9-9C0F-4870-977D-9F4719490637}" type="datetime1">
              <a:rPr lang="en-GB" smtClean="0"/>
              <a:t>26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70758E-E054-4DD6-9D4C-9AB156DE4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EFE247-863B-444F-9BDC-7A4F37C61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7954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F9C0A3-5D3C-4B49-8F18-268974FC96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BADBCA-4CA3-4C59-86A6-6145538C62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271BA5-1219-4CA6-93CB-CBB41821F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3E06F-DB3E-4ABC-A30C-CFE87ED40FA9}" type="datetime1">
              <a:rPr lang="en-GB" smtClean="0"/>
              <a:t>26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AF40CC-1255-45AA-BBA8-B986B2186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1B76A2-FBF5-4A7A-AA76-F39F940B7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9966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B5BDD5-CE24-4935-B1FA-069BDE3597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C41B67-D2B4-435B-96AB-B9F9927C71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68B367-7466-408A-8030-13602F065E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801F87-C3F5-4E97-94AC-E956A0AB0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8EA2F-7C6B-4FCD-9619-ACCCD99CCC89}" type="datetime1">
              <a:rPr lang="en-GB" smtClean="0"/>
              <a:t>26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3E5141-783B-43F1-AA64-9664648B1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12EACE-7432-4EFA-8332-9A3DC9C119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2503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FF4E80-93AB-44AD-9BAF-AFF4A504B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43423B-CD34-4D86-B159-247096D833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7540B0-990D-49FE-9993-BA8AE7D9DA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2E96E8-82DE-4F88-8E24-CA87AE8766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140A41-81BE-435F-A65A-542EDFA484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BD135C-DC05-4F2A-9D35-0E65CB8C7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8C9D0-BCF1-4095-B8BB-A3A90666C9B8}" type="datetime1">
              <a:rPr lang="en-GB" smtClean="0"/>
              <a:t>26/01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DA7565-AE9F-455C-96FE-B2C0ED884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F3ABC6-E473-40B7-A80A-279D9FCBC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2921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E6679-583A-41A8-8E02-1B0F1AEED1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2C071F-4C47-49D0-BA04-5738190C3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2ADE4-1D93-4516-9BA3-E7A6A8375621}" type="datetime1">
              <a:rPr lang="en-GB" smtClean="0"/>
              <a:t>26/01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E67714-9A79-4596-9631-970247A12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D9CB41-69AB-4B26-B79B-94389B491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9965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3C1C86-BD65-47D5-A55D-2527F5E2C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6F432-BD31-45DB-BB99-A27E0A888281}" type="datetime1">
              <a:rPr lang="en-GB" smtClean="0"/>
              <a:t>26/01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B8912A-C594-4EAF-8717-9BDA211E90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6DB5F7-18A6-490B-B04F-61FACEB0A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2116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EFE812-5AED-4543-9AA8-BF258FC2D1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F5811A-3F40-4208-9526-116F744145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054B59-8CAF-4BA4-B8CF-3E957B20B6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658743-07C6-4E83-855D-A22AB1CB69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4ED80-8C5B-4CF6-8FE0-FCB4383ED538}" type="datetime1">
              <a:rPr lang="en-GB" smtClean="0"/>
              <a:t>26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4919C7-01EC-4143-9332-94DD98E166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74F9E0-578A-4DEA-824C-5901EFE85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4325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3D673C-6A13-42F3-8805-3EE488C41D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F25DB7-0944-4B1E-9F85-E2E3BFE876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010AA1-C094-48E2-8AAB-28E16AD4D9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2A82A5-74FD-46A5-8A87-A68391252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7791-0F88-44AF-A9A2-C6C3F27D84D4}" type="datetime1">
              <a:rPr lang="en-GB" smtClean="0"/>
              <a:t>26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1504EC-C3D8-425B-A624-B3C729364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497340-E386-484E-AED0-068A687F8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8485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C60117-987E-43D0-9EC0-0489B6D399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A5E569-B344-449C-815C-ACC23087CF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32FF89-C687-4516-B4E8-ECB67FCE92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C07231-2033-4887-ACE6-BD455F6CF343}" type="datetime1">
              <a:rPr lang="en-GB" smtClean="0"/>
              <a:t>26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B6B944-5946-4844-B56F-DEABB86227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BCF89E-1891-4B15-9707-9ECB30FEDB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BB9DF-8C0F-40A5-8771-5A9BF8AD71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2981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07FB2FC7-07D4-4139-9097-DEA4C09B0EAF}"/>
              </a:ext>
            </a:extLst>
          </p:cNvPr>
          <p:cNvSpPr txBox="1"/>
          <p:nvPr/>
        </p:nvSpPr>
        <p:spPr>
          <a:xfrm>
            <a:off x="1100578" y="4777473"/>
            <a:ext cx="101054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.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hemical structures of (A) trichothecene core, and (B) diacetoxyscirpenol (DAS). The chemical structures of trichothecene core and diacetoxyscirpenol were adapted from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Fk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(2005) and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Yikrazuul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(2009) respectively.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72291B02-42A4-42A2-A806-8C8746CF2E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0578" y="2203540"/>
            <a:ext cx="3987453" cy="25200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ECB00A83-EC35-4154-A87A-AB13D73767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203540"/>
            <a:ext cx="3741422" cy="2520000"/>
          </a:xfrm>
          <a:prstGeom prst="rect">
            <a:avLst/>
          </a:prstGeom>
        </p:spPr>
      </p:pic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8D602B58-89C2-4C8D-8832-EAA898343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BB9DF-8C0F-40A5-8771-5A9BF8AD7162}" type="slidenum">
              <a:rPr lang="en-GB" smtClean="0"/>
              <a:t>1</a:t>
            </a:fld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40DC60D-F526-4599-A306-EF45F372881E}"/>
              </a:ext>
            </a:extLst>
          </p:cNvPr>
          <p:cNvSpPr txBox="1"/>
          <p:nvPr/>
        </p:nvSpPr>
        <p:spPr>
          <a:xfrm>
            <a:off x="1043259" y="5624721"/>
            <a:ext cx="1010548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Fk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(2005). Chemical structure of Trichothecenes.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https://en.wikipedia.org/wiki/Trichothecene#/media/File:Trichothecenes.png</a:t>
            </a:r>
          </a:p>
          <a:p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Yikrazuul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(2009). diacetoxyscirpenol; Anguidine; diacetoxyscirpenol;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Anguidin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; 4,15-Diacetoxyscirpenol. 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https://en.wikipedia.org/wiki/Diacetoxyscirpenol#/media/File:Diacetoxyscirpenol.svg</a:t>
            </a:r>
          </a:p>
        </p:txBody>
      </p:sp>
      <p:sp>
        <p:nvSpPr>
          <p:cNvPr id="3" name="Rectangle 1">
            <a:extLst>
              <a:ext uri="{FF2B5EF4-FFF2-40B4-BE49-F238E27FC236}">
                <a16:creationId xmlns:a16="http://schemas.microsoft.com/office/drawing/2014/main" id="{C40C7A6D-7A25-458F-8C25-9BD0A45237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159" y="79980"/>
            <a:ext cx="8672567" cy="1738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kumimoji="0" lang="en-GB" altLang="en-US" sz="11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acetoxyscirpenol, a </a:t>
            </a:r>
            <a:r>
              <a:rPr kumimoji="0" lang="en-GB" altLang="en-US" sz="1100" b="1" i="1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usarium </a:t>
            </a:r>
            <a:r>
              <a:rPr kumimoji="0" lang="en-GB" altLang="en-US" sz="11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p. exometabolite, prevents efficiently the incidence of the parasitic weed </a:t>
            </a:r>
            <a:r>
              <a:rPr kumimoji="0" lang="en-GB" altLang="en-US" sz="1100" b="1" i="1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iga hermonthica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1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kumimoji="0" lang="en-GB" altLang="en-US" sz="1100" b="0" i="0" u="none" strike="noStrike" cap="none" normalizeH="0" baseline="0" dirty="0" bmk="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en-US" sz="1100" b="0" i="0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lliams Oyifioda Anteyi</a:t>
            </a:r>
            <a:r>
              <a:rPr kumimoji="0" lang="de-DE" altLang="en-US" sz="1100" b="0" i="0" u="none" strike="noStrike" cap="none" normalizeH="0" baseline="30000" dirty="0" bmk="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kumimoji="0" lang="de-DE" altLang="en-US" sz="1100" b="0" i="0" u="none" strike="noStrike" cap="none" normalizeH="0" baseline="0" dirty="0" bmk="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Iris Klaiber</a:t>
            </a:r>
            <a:r>
              <a:rPr kumimoji="0" lang="de-DE" altLang="en-US" sz="1100" b="0" i="0" u="none" strike="noStrike" cap="none" normalizeH="0" baseline="30000" dirty="0" bmk="_Hlk13574906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kumimoji="0" lang="de-DE" altLang="en-US" sz="1100" b="0" i="0" u="none" strike="noStrike" cap="none" normalizeH="0" baseline="0" dirty="0" bmk="_Hlk13574906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Frank Rasche</a:t>
            </a:r>
            <a:r>
              <a:rPr kumimoji="0" lang="de-DE" altLang="en-US" sz="1100" b="0" i="0" u="none" strike="noStrike" cap="none" normalizeH="0" baseline="30000" dirty="0" bmk="_Hlk13574906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kumimoji="0" lang="de-DE" altLang="en-US" sz="1100" b="0" i="0" u="none" strike="noStrike" cap="none" normalizeH="0" baseline="0" dirty="0" bmk="_Hlk13574906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1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stitute of Agricultural Sciences in the Tropics (Hans-Ruthenberg-Institute), University of Hohenheim, 70593 Stuttgart, Germany.</a:t>
            </a:r>
            <a:endParaRPr kumimoji="0" lang="en-GB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1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e Facility Hohenheim, University of Hohenheim, 70593 Stuttgart, Germany.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Corresponding author:</a:t>
            </a:r>
            <a:endParaRPr kumimoji="0" lang="en-GB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f. Dr. Frank Rasche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mail: frank.rasche@uni-hohenheim.de</a:t>
            </a:r>
            <a:r>
              <a:rPr kumimoji="0" lang="en-GB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47584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6</TotalTime>
  <Words>184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iams Anteyi</dc:creator>
  <cp:lastModifiedBy>Williams Anteyi</cp:lastModifiedBy>
  <cp:revision>135</cp:revision>
  <cp:lastPrinted>2021-04-16T17:02:31Z</cp:lastPrinted>
  <dcterms:created xsi:type="dcterms:W3CDTF">2021-04-09T12:49:52Z</dcterms:created>
  <dcterms:modified xsi:type="dcterms:W3CDTF">2022-01-26T13:00:59Z</dcterms:modified>
</cp:coreProperties>
</file>